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38" r:id="rId2"/>
  </p:sldIdLst>
  <p:sldSz cx="9144000" cy="6858000" type="screen4x3"/>
  <p:notesSz cx="7010400" cy="92964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9999"/>
    <a:srgbClr val="5CA0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050" autoAdjust="0"/>
    <p:restoredTop sz="87515" autoAdjust="0"/>
  </p:normalViewPr>
  <p:slideViewPr>
    <p:cSldViewPr snapToGrid="0" snapToObjects="1">
      <p:cViewPr>
        <p:scale>
          <a:sx n="90" d="100"/>
          <a:sy n="90" d="100"/>
        </p:scale>
        <p:origin x="-894" y="-3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665311277159614E-2"/>
          <c:y val="2.6733500097536746E-2"/>
          <c:w val="0.94334688722840387"/>
          <c:h val="0.719464003958190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SOX9 ChIP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E$2:$E$17</c:f>
                <c:numCache>
                  <c:formatCode>General</c:formatCode>
                  <c:ptCount val="16"/>
                  <c:pt idx="0">
                    <c:v>0.11862410311887017</c:v>
                  </c:pt>
                  <c:pt idx="1">
                    <c:v>0.25462306536717039</c:v>
                  </c:pt>
                  <c:pt idx="2">
                    <c:v>1.3257838012397503</c:v>
                  </c:pt>
                  <c:pt idx="3">
                    <c:v>1.3176397398325042</c:v>
                  </c:pt>
                  <c:pt idx="4">
                    <c:v>0.72403127075497953</c:v>
                  </c:pt>
                  <c:pt idx="5">
                    <c:v>0.48073600524329746</c:v>
                  </c:pt>
                  <c:pt idx="6">
                    <c:v>0.27294867171362014</c:v>
                  </c:pt>
                  <c:pt idx="7">
                    <c:v>0.12922861132146704</c:v>
                  </c:pt>
                  <c:pt idx="8">
                    <c:v>1.4077854958799494</c:v>
                  </c:pt>
                  <c:pt idx="9">
                    <c:v>0.19116807862701729</c:v>
                  </c:pt>
                  <c:pt idx="10">
                    <c:v>0.37495834499721303</c:v>
                  </c:pt>
                  <c:pt idx="11">
                    <c:v>2.091463748202639</c:v>
                  </c:pt>
                  <c:pt idx="12">
                    <c:v>1.8627691101512076</c:v>
                  </c:pt>
                  <c:pt idx="13">
                    <c:v>0.4142972795978615</c:v>
                  </c:pt>
                  <c:pt idx="14">
                    <c:v>2.2848308893388887</c:v>
                  </c:pt>
                  <c:pt idx="15">
                    <c:v>0.19560411260188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2!$A$2:$A$17</c:f>
              <c:strCache>
                <c:ptCount val="16"/>
                <c:pt idx="0">
                  <c:v>Neg</c:v>
                </c:pt>
                <c:pt idx="1">
                  <c:v>ANKRD39</c:v>
                </c:pt>
                <c:pt idx="2">
                  <c:v>ASPM</c:v>
                </c:pt>
                <c:pt idx="3">
                  <c:v>CENPA</c:v>
                </c:pt>
                <c:pt idx="4">
                  <c:v>FRYL</c:v>
                </c:pt>
                <c:pt idx="5">
                  <c:v>GATAD2B</c:v>
                </c:pt>
                <c:pt idx="6">
                  <c:v>HMGCS1</c:v>
                </c:pt>
                <c:pt idx="7">
                  <c:v>HNRNPAB</c:v>
                </c:pt>
                <c:pt idx="8">
                  <c:v>KCTD7</c:v>
                </c:pt>
                <c:pt idx="9">
                  <c:v>KIF1B</c:v>
                </c:pt>
                <c:pt idx="10">
                  <c:v>RBM27</c:v>
                </c:pt>
                <c:pt idx="11">
                  <c:v>RRBP1</c:v>
                </c:pt>
                <c:pt idx="12">
                  <c:v>SAP30L</c:v>
                </c:pt>
                <c:pt idx="13">
                  <c:v>STIL</c:v>
                </c:pt>
                <c:pt idx="14">
                  <c:v>TNRC6B</c:v>
                </c:pt>
                <c:pt idx="15">
                  <c:v>ZNF92</c:v>
                </c:pt>
              </c:strCache>
            </c:strRef>
          </c:cat>
          <c:val>
            <c:numRef>
              <c:f>Sheet2!$B$2:$B$17</c:f>
              <c:numCache>
                <c:formatCode>General</c:formatCode>
                <c:ptCount val="16"/>
                <c:pt idx="0">
                  <c:v>0.97366587320962594</c:v>
                </c:pt>
                <c:pt idx="1">
                  <c:v>6.6053748786280373</c:v>
                </c:pt>
                <c:pt idx="2">
                  <c:v>7.4053842721527205</c:v>
                </c:pt>
                <c:pt idx="3">
                  <c:v>4.7172296400459306</c:v>
                </c:pt>
                <c:pt idx="4">
                  <c:v>8.6008816766276794</c:v>
                </c:pt>
                <c:pt idx="5">
                  <c:v>7.8463468028736019</c:v>
                </c:pt>
                <c:pt idx="6">
                  <c:v>6.7498352763582901</c:v>
                </c:pt>
                <c:pt idx="7">
                  <c:v>3.9625816387765331</c:v>
                </c:pt>
                <c:pt idx="8">
                  <c:v>6.8376493617311995</c:v>
                </c:pt>
                <c:pt idx="9">
                  <c:v>6.5255716005456774</c:v>
                </c:pt>
                <c:pt idx="10">
                  <c:v>5.4212707413651007</c:v>
                </c:pt>
                <c:pt idx="11">
                  <c:v>9.6272655397034956</c:v>
                </c:pt>
                <c:pt idx="12">
                  <c:v>6.9902756643025183</c:v>
                </c:pt>
                <c:pt idx="13">
                  <c:v>5.6402831643057327</c:v>
                </c:pt>
                <c:pt idx="14">
                  <c:v>16.662695313293835</c:v>
                </c:pt>
                <c:pt idx="15">
                  <c:v>5.8683761578676474</c:v>
                </c:pt>
              </c:numCache>
            </c:numRef>
          </c:val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NF-YA ChIP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F$2:$F$17</c:f>
                <c:numCache>
                  <c:formatCode>General</c:formatCode>
                  <c:ptCount val="16"/>
                  <c:pt idx="0">
                    <c:v>0.13023480758017117</c:v>
                  </c:pt>
                  <c:pt idx="1">
                    <c:v>0.30733752914800605</c:v>
                  </c:pt>
                  <c:pt idx="2">
                    <c:v>1.8407538653290385</c:v>
                  </c:pt>
                  <c:pt idx="3">
                    <c:v>0.61552233750291352</c:v>
                  </c:pt>
                  <c:pt idx="4">
                    <c:v>0.66090817045364503</c:v>
                  </c:pt>
                  <c:pt idx="5">
                    <c:v>1.1703720474367711</c:v>
                  </c:pt>
                  <c:pt idx="6">
                    <c:v>0.12466610549533945</c:v>
                  </c:pt>
                  <c:pt idx="7">
                    <c:v>0.6802027454271512</c:v>
                  </c:pt>
                  <c:pt idx="8">
                    <c:v>0.35454903173903746</c:v>
                  </c:pt>
                  <c:pt idx="9">
                    <c:v>1.0413090247329029</c:v>
                  </c:pt>
                  <c:pt idx="10">
                    <c:v>0.94812743975624547</c:v>
                  </c:pt>
                  <c:pt idx="11">
                    <c:v>1.1912617463869344</c:v>
                  </c:pt>
                  <c:pt idx="12">
                    <c:v>3.57767372994592</c:v>
                  </c:pt>
                  <c:pt idx="13">
                    <c:v>1.1986825882723471</c:v>
                  </c:pt>
                  <c:pt idx="14">
                    <c:v>0.96657381445819923</c:v>
                  </c:pt>
                  <c:pt idx="15">
                    <c:v>0.354133542336357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2!$A$2:$A$17</c:f>
              <c:strCache>
                <c:ptCount val="16"/>
                <c:pt idx="0">
                  <c:v>Neg</c:v>
                </c:pt>
                <c:pt idx="1">
                  <c:v>ANKRD39</c:v>
                </c:pt>
                <c:pt idx="2">
                  <c:v>ASPM</c:v>
                </c:pt>
                <c:pt idx="3">
                  <c:v>CENPA</c:v>
                </c:pt>
                <c:pt idx="4">
                  <c:v>FRYL</c:v>
                </c:pt>
                <c:pt idx="5">
                  <c:v>GATAD2B</c:v>
                </c:pt>
                <c:pt idx="6">
                  <c:v>HMGCS1</c:v>
                </c:pt>
                <c:pt idx="7">
                  <c:v>HNRNPAB</c:v>
                </c:pt>
                <c:pt idx="8">
                  <c:v>KCTD7</c:v>
                </c:pt>
                <c:pt idx="9">
                  <c:v>KIF1B</c:v>
                </c:pt>
                <c:pt idx="10">
                  <c:v>RBM27</c:v>
                </c:pt>
                <c:pt idx="11">
                  <c:v>RRBP1</c:v>
                </c:pt>
                <c:pt idx="12">
                  <c:v>SAP30L</c:v>
                </c:pt>
                <c:pt idx="13">
                  <c:v>STIL</c:v>
                </c:pt>
                <c:pt idx="14">
                  <c:v>TNRC6B</c:v>
                </c:pt>
                <c:pt idx="15">
                  <c:v>ZNF92</c:v>
                </c:pt>
              </c:strCache>
            </c:strRef>
          </c:cat>
          <c:val>
            <c:numRef>
              <c:f>Sheet2!$C$2:$C$17</c:f>
              <c:numCache>
                <c:formatCode>General</c:formatCode>
                <c:ptCount val="16"/>
                <c:pt idx="0">
                  <c:v>0.85871442159012901</c:v>
                </c:pt>
                <c:pt idx="1">
                  <c:v>7.0205613006659853</c:v>
                </c:pt>
                <c:pt idx="2">
                  <c:v>9.4909811444000258</c:v>
                </c:pt>
                <c:pt idx="3">
                  <c:v>10.594312940681746</c:v>
                </c:pt>
                <c:pt idx="4">
                  <c:v>11.025049603283106</c:v>
                </c:pt>
                <c:pt idx="5">
                  <c:v>8.2831333829005089</c:v>
                </c:pt>
                <c:pt idx="6">
                  <c:v>6.801918028390741</c:v>
                </c:pt>
                <c:pt idx="7">
                  <c:v>9.9392767081649485</c:v>
                </c:pt>
                <c:pt idx="8">
                  <c:v>6.7843780673245728</c:v>
                </c:pt>
                <c:pt idx="9">
                  <c:v>8.6328479487017322</c:v>
                </c:pt>
                <c:pt idx="10">
                  <c:v>6.8835990677602368</c:v>
                </c:pt>
                <c:pt idx="11">
                  <c:v>10.124353767499565</c:v>
                </c:pt>
                <c:pt idx="12">
                  <c:v>16.013268538269376</c:v>
                </c:pt>
                <c:pt idx="13">
                  <c:v>8.5232856475466807</c:v>
                </c:pt>
                <c:pt idx="14">
                  <c:v>18.981284721150271</c:v>
                </c:pt>
                <c:pt idx="15">
                  <c:v>6.56698400707517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2698368"/>
        <c:axId val="122724736"/>
      </c:barChart>
      <c:catAx>
        <c:axId val="122698368"/>
        <c:scaling>
          <c:orientation val="minMax"/>
        </c:scaling>
        <c:delete val="0"/>
        <c:axPos val="b"/>
        <c:numFmt formatCode="General" sourceLinked="1"/>
        <c:majorTickMark val="in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2724736"/>
        <c:crosses val="autoZero"/>
        <c:auto val="1"/>
        <c:lblAlgn val="ctr"/>
        <c:lblOffset val="100"/>
        <c:noMultiLvlLbl val="0"/>
      </c:catAx>
      <c:valAx>
        <c:axId val="122724736"/>
        <c:scaling>
          <c:orientation val="minMax"/>
        </c:scaling>
        <c:delete val="0"/>
        <c:axPos val="l"/>
        <c:numFmt formatCode="General" sourceLinked="1"/>
        <c:majorTickMark val="in"/>
        <c:minorTickMark val="in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2698368"/>
        <c:crosses val="autoZero"/>
        <c:crossBetween val="between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7.0463032947127052E-2"/>
          <c:y val="2.7843004545710622E-3"/>
          <c:w val="0.23371941204797761"/>
          <c:h val="7.8437680046091793E-2"/>
        </c:manualLayout>
      </c:layout>
      <c:overlay val="0"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1B45C1-70C3-46D4-A32A-FEF0581B8A5B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pPr lvl="0"/>
            <a:endParaRPr 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altLang="en-US" smtClean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197D4DD6-878A-4260-A1E7-ACE1E5C6D78E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11774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3EAE41D-2269-4843-8591-71C50AAC54BE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DDE7CE2-2D80-40F5-ABAC-8DE69FF83D39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44653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39B5717-CCCB-4FCC-B6DE-385F92E03DA6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ADEAB87-A5B5-44D2-8973-06B1501D6E7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59841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70D7AE9-D5BB-4A40-92F2-1A42C23B9134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AD86FC-0FFD-437C-A4A1-AD4734B614C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2226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9AD9D0F-96BD-45CF-98FC-244FD5D9E65A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AB62F0-F8E4-48F3-BEFD-4A18B9EB52E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61588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DAA410-CDC7-4019-A096-24A8B774AE40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0B0FEA-C3B0-4788-9007-28C3C6A2343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84402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92A3EB-8E61-4E4D-9D10-C62C6723DAFA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99C0D-0EEF-4CC2-8A8B-BCAA9A67A1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27628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B5F3BEC-C0FB-49C7-8277-2CCE1C67C53A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811DA4F-9054-46D9-805D-342878FF837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52543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4560479-DC70-46D5-AB77-FF9A6C1DDE94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D43EBC1-E17E-4201-A773-5D61902CA3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6143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9C22A94-A4ED-47F0-B336-47B01763B61B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57B61B1-0937-446C-A80A-89B6E80C866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16877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44B365-877C-40C4-AA09-1F761367865E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B3C69BA-C42F-4B47-A7DC-D122A206286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8573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D234A69-B555-4775-91C3-908FFDC622B8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AB703BB-9289-49B9-BB2D-7ED69C5982C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33469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512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2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fld id="{ED3AAABA-8377-4DC6-85F9-8CCA4D29B76F}" type="datetimeFigureOut">
              <a:rPr lang="en-US" altLang="en-US"/>
              <a:pPr/>
              <a:t>5/12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7098F2EA-2152-4D8B-AE61-139F6DDF9A3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" Type="http://schemas.openxmlformats.org/officeDocument/2006/relationships/chart" Target="../charts/chart1.xml"/><Relationship Id="rId16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3429371"/>
              </p:ext>
            </p:extLst>
          </p:nvPr>
        </p:nvGraphicFramePr>
        <p:xfrm>
          <a:off x="293585" y="4110227"/>
          <a:ext cx="7839075" cy="2609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 rot="16200000">
            <a:off x="-215834" y="4887369"/>
            <a:ext cx="1143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% of input</a:t>
            </a:r>
            <a:endParaRPr lang="en-US" sz="1200" dirty="0"/>
          </a:p>
        </p:txBody>
      </p:sp>
      <p:grpSp>
        <p:nvGrpSpPr>
          <p:cNvPr id="65" name="Group 64"/>
          <p:cNvGrpSpPr/>
          <p:nvPr/>
        </p:nvGrpSpPr>
        <p:grpSpPr>
          <a:xfrm>
            <a:off x="2057826" y="539869"/>
            <a:ext cx="1726397" cy="1148257"/>
            <a:chOff x="3607603" y="66158"/>
            <a:chExt cx="1726397" cy="1148257"/>
          </a:xfrm>
        </p:grpSpPr>
        <p:pic>
          <p:nvPicPr>
            <p:cNvPr id="1028" name="Picture 4" descr="H:\gene\New folder\ASPM.jpe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07603" y="136795"/>
              <a:ext cx="1726397" cy="10776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>
              <a:off x="3607603" y="66158"/>
              <a:ext cx="669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ASPM</a:t>
              </a:r>
              <a:endParaRPr lang="en-US" sz="800" dirty="0"/>
            </a:p>
          </p:txBody>
        </p:sp>
      </p:grpSp>
      <p:grpSp>
        <p:nvGrpSpPr>
          <p:cNvPr id="71" name="Group 70"/>
          <p:cNvGrpSpPr/>
          <p:nvPr/>
        </p:nvGrpSpPr>
        <p:grpSpPr>
          <a:xfrm>
            <a:off x="242367" y="529329"/>
            <a:ext cx="1676400" cy="1142389"/>
            <a:chOff x="1855003" y="56422"/>
            <a:chExt cx="1676400" cy="1142389"/>
          </a:xfrm>
        </p:grpSpPr>
        <p:pic>
          <p:nvPicPr>
            <p:cNvPr id="1027" name="Picture 3" descr="H:\gene\New folder\ANKRD39.jpe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55003" y="152400"/>
              <a:ext cx="1676400" cy="104641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1856995" y="56422"/>
              <a:ext cx="669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ANKRD39</a:t>
              </a:r>
              <a:endParaRPr lang="en-US" sz="800" dirty="0"/>
            </a:p>
          </p:txBody>
        </p:sp>
        <p:grpSp>
          <p:nvGrpSpPr>
            <p:cNvPr id="24" name="Group 23"/>
            <p:cNvGrpSpPr/>
            <p:nvPr/>
          </p:nvGrpSpPr>
          <p:grpSpPr>
            <a:xfrm>
              <a:off x="2494236" y="156129"/>
              <a:ext cx="629964" cy="682071"/>
              <a:chOff x="813925" y="156129"/>
              <a:chExt cx="629964" cy="682071"/>
            </a:xfrm>
          </p:grpSpPr>
          <p:sp>
            <p:nvSpPr>
              <p:cNvPr id="25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26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27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</p:grpSp>
      <p:grpSp>
        <p:nvGrpSpPr>
          <p:cNvPr id="28" name="Group 27"/>
          <p:cNvGrpSpPr/>
          <p:nvPr/>
        </p:nvGrpSpPr>
        <p:grpSpPr>
          <a:xfrm>
            <a:off x="2687456" y="610071"/>
            <a:ext cx="629964" cy="713715"/>
            <a:chOff x="813925" y="156129"/>
            <a:chExt cx="629964" cy="713715"/>
          </a:xfrm>
        </p:grpSpPr>
        <p:sp>
          <p:nvSpPr>
            <p:cNvPr id="29" name="TextBox 54"/>
            <p:cNvSpPr txBox="1">
              <a:spLocks noChangeArrowheads="1"/>
            </p:cNvSpPr>
            <p:nvPr/>
          </p:nvSpPr>
          <p:spPr bwMode="auto">
            <a:xfrm>
              <a:off x="821789" y="156129"/>
              <a:ext cx="55488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9pPr>
            </a:lstStyle>
            <a:p>
              <a:pPr eaLnBrk="1" hangingPunct="1"/>
              <a:r>
                <a:rPr lang="en-US" altLang="en-US" sz="800" dirty="0">
                  <a:solidFill>
                    <a:srgbClr val="FF0000"/>
                  </a:solidFill>
                </a:rPr>
                <a:t>SOX9</a:t>
              </a:r>
            </a:p>
          </p:txBody>
        </p:sp>
        <p:sp>
          <p:nvSpPr>
            <p:cNvPr id="30" name="TextBox 55"/>
            <p:cNvSpPr txBox="1">
              <a:spLocks noChangeArrowheads="1"/>
            </p:cNvSpPr>
            <p:nvPr/>
          </p:nvSpPr>
          <p:spPr bwMode="auto">
            <a:xfrm>
              <a:off x="813925" y="391212"/>
              <a:ext cx="62996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9pPr>
            </a:lstStyle>
            <a:p>
              <a:pPr eaLnBrk="1" hangingPunct="1"/>
              <a:r>
                <a:rPr lang="en-US" altLang="en-US" sz="800" dirty="0">
                  <a:solidFill>
                    <a:srgbClr val="0070C0"/>
                  </a:solidFill>
                </a:rPr>
                <a:t>NF-YA</a:t>
              </a:r>
            </a:p>
          </p:txBody>
        </p:sp>
        <p:sp>
          <p:nvSpPr>
            <p:cNvPr id="31" name="TextBox 56"/>
            <p:cNvSpPr txBox="1">
              <a:spLocks noChangeArrowheads="1"/>
            </p:cNvSpPr>
            <p:nvPr/>
          </p:nvSpPr>
          <p:spPr bwMode="auto">
            <a:xfrm>
              <a:off x="832193" y="654400"/>
              <a:ext cx="54800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9pPr>
            </a:lstStyle>
            <a:p>
              <a:pPr eaLnBrk="1" hangingPunct="1"/>
              <a:r>
                <a:rPr lang="en-US" altLang="en-US" sz="800" dirty="0"/>
                <a:t>input</a:t>
              </a:r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3848503" y="533993"/>
            <a:ext cx="1681037" cy="1154133"/>
            <a:chOff x="5436402" y="44678"/>
            <a:chExt cx="1681037" cy="1154133"/>
          </a:xfrm>
        </p:grpSpPr>
        <p:pic>
          <p:nvPicPr>
            <p:cNvPr id="1029" name="Picture 5" descr="H:\gene\New folder\CENPA.jpe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402" y="121191"/>
              <a:ext cx="1681037" cy="10776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TextBox 14"/>
            <p:cNvSpPr txBox="1"/>
            <p:nvPr/>
          </p:nvSpPr>
          <p:spPr>
            <a:xfrm>
              <a:off x="5471039" y="44678"/>
              <a:ext cx="669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CENPA</a:t>
              </a:r>
              <a:endParaRPr lang="en-US" sz="800" dirty="0"/>
            </a:p>
          </p:txBody>
        </p:sp>
        <p:grpSp>
          <p:nvGrpSpPr>
            <p:cNvPr id="32" name="Group 31"/>
            <p:cNvGrpSpPr/>
            <p:nvPr/>
          </p:nvGrpSpPr>
          <p:grpSpPr>
            <a:xfrm>
              <a:off x="6096000" y="152400"/>
              <a:ext cx="629964" cy="682071"/>
              <a:chOff x="813925" y="156129"/>
              <a:chExt cx="629964" cy="682071"/>
            </a:xfrm>
          </p:grpSpPr>
          <p:sp>
            <p:nvSpPr>
              <p:cNvPr id="33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34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35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</p:grpSp>
      <p:sp>
        <p:nvSpPr>
          <p:cNvPr id="44" name="TextBox 57"/>
          <p:cNvSpPr txBox="1">
            <a:spLocks noChangeArrowheads="1"/>
          </p:cNvSpPr>
          <p:nvPr/>
        </p:nvSpPr>
        <p:spPr bwMode="auto">
          <a:xfrm rot="16200000">
            <a:off x="-107343" y="882744"/>
            <a:ext cx="5139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US" altLang="en-US" sz="800" dirty="0"/>
              <a:t>reads</a:t>
            </a:r>
          </a:p>
        </p:txBody>
      </p:sp>
      <p:grpSp>
        <p:nvGrpSpPr>
          <p:cNvPr id="53" name="Group 52"/>
          <p:cNvGrpSpPr/>
          <p:nvPr/>
        </p:nvGrpSpPr>
        <p:grpSpPr>
          <a:xfrm>
            <a:off x="5558829" y="547027"/>
            <a:ext cx="1604842" cy="1170443"/>
            <a:chOff x="162531" y="1192870"/>
            <a:chExt cx="1604842" cy="1170443"/>
          </a:xfrm>
        </p:grpSpPr>
        <p:pic>
          <p:nvPicPr>
            <p:cNvPr id="1031" name="Picture 7" descr="H:\gene\New folder\FRYL.jpe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8603" y="1287558"/>
              <a:ext cx="1588770" cy="107575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0" name="Group 39"/>
            <p:cNvGrpSpPr/>
            <p:nvPr/>
          </p:nvGrpSpPr>
          <p:grpSpPr>
            <a:xfrm>
              <a:off x="817836" y="1371600"/>
              <a:ext cx="629964" cy="682071"/>
              <a:chOff x="813925" y="156129"/>
              <a:chExt cx="629964" cy="682071"/>
            </a:xfrm>
          </p:grpSpPr>
          <p:sp>
            <p:nvSpPr>
              <p:cNvPr id="41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42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43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  <p:sp>
          <p:nvSpPr>
            <p:cNvPr id="45" name="TextBox 44"/>
            <p:cNvSpPr txBox="1"/>
            <p:nvPr/>
          </p:nvSpPr>
          <p:spPr>
            <a:xfrm>
              <a:off x="162531" y="1192870"/>
              <a:ext cx="5772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FRYL</a:t>
              </a:r>
              <a:endParaRPr lang="en-US" sz="800" dirty="0"/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7330172" y="610071"/>
            <a:ext cx="1705320" cy="1109142"/>
            <a:chOff x="1855003" y="1263878"/>
            <a:chExt cx="1705320" cy="1109142"/>
          </a:xfrm>
        </p:grpSpPr>
        <p:pic>
          <p:nvPicPr>
            <p:cNvPr id="1032" name="Picture 8" descr="H:\gene\New folder\GATAD2B.jpe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55003" y="1308556"/>
              <a:ext cx="1705320" cy="106446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8" name="TextBox 47"/>
            <p:cNvSpPr txBox="1"/>
            <p:nvPr/>
          </p:nvSpPr>
          <p:spPr>
            <a:xfrm>
              <a:off x="1856995" y="1263878"/>
              <a:ext cx="669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GATAD2B</a:t>
              </a:r>
              <a:endParaRPr lang="en-US" sz="800" dirty="0"/>
            </a:p>
          </p:txBody>
        </p:sp>
        <p:grpSp>
          <p:nvGrpSpPr>
            <p:cNvPr id="49" name="Group 48"/>
            <p:cNvGrpSpPr/>
            <p:nvPr/>
          </p:nvGrpSpPr>
          <p:grpSpPr>
            <a:xfrm>
              <a:off x="2494236" y="1347915"/>
              <a:ext cx="629964" cy="682071"/>
              <a:chOff x="813925" y="156129"/>
              <a:chExt cx="629964" cy="682071"/>
            </a:xfrm>
          </p:grpSpPr>
          <p:sp>
            <p:nvSpPr>
              <p:cNvPr id="50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51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52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</p:grpSp>
      <p:grpSp>
        <p:nvGrpSpPr>
          <p:cNvPr id="46" name="Group 45"/>
          <p:cNvGrpSpPr/>
          <p:nvPr/>
        </p:nvGrpSpPr>
        <p:grpSpPr>
          <a:xfrm>
            <a:off x="246745" y="1688126"/>
            <a:ext cx="1694070" cy="1145691"/>
            <a:chOff x="3639931" y="1216509"/>
            <a:chExt cx="1694070" cy="1145691"/>
          </a:xfrm>
        </p:grpSpPr>
        <p:pic>
          <p:nvPicPr>
            <p:cNvPr id="1033" name="Picture 9" descr="H:\gene\New folder\HMGCS1.jpeg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9931" y="1304759"/>
              <a:ext cx="1694070" cy="105744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4" name="TextBox 53"/>
            <p:cNvSpPr txBox="1"/>
            <p:nvPr/>
          </p:nvSpPr>
          <p:spPr>
            <a:xfrm>
              <a:off x="3639931" y="1216509"/>
              <a:ext cx="669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HMGCS1</a:t>
              </a:r>
              <a:endParaRPr lang="en-US" sz="800" dirty="0"/>
            </a:p>
          </p:txBody>
        </p:sp>
        <p:grpSp>
          <p:nvGrpSpPr>
            <p:cNvPr id="55" name="Group 54"/>
            <p:cNvGrpSpPr/>
            <p:nvPr/>
          </p:nvGrpSpPr>
          <p:grpSpPr>
            <a:xfrm>
              <a:off x="4246836" y="1337282"/>
              <a:ext cx="629964" cy="682071"/>
              <a:chOff x="813925" y="156129"/>
              <a:chExt cx="629964" cy="682071"/>
            </a:xfrm>
          </p:grpSpPr>
          <p:sp>
            <p:nvSpPr>
              <p:cNvPr id="56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57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58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</p:grpSp>
      <p:grpSp>
        <p:nvGrpSpPr>
          <p:cNvPr id="23" name="Group 22"/>
          <p:cNvGrpSpPr/>
          <p:nvPr/>
        </p:nvGrpSpPr>
        <p:grpSpPr>
          <a:xfrm>
            <a:off x="2052375" y="1671718"/>
            <a:ext cx="1726397" cy="1173776"/>
            <a:chOff x="5436403" y="1167723"/>
            <a:chExt cx="1726397" cy="1173776"/>
          </a:xfrm>
        </p:grpSpPr>
        <p:pic>
          <p:nvPicPr>
            <p:cNvPr id="1034" name="Picture 10" descr="H:\gene\New folder\HNRNPAB.jpe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403" y="1263879"/>
              <a:ext cx="1726397" cy="10776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0" name="TextBox 59"/>
            <p:cNvSpPr txBox="1"/>
            <p:nvPr/>
          </p:nvSpPr>
          <p:spPr>
            <a:xfrm>
              <a:off x="5486400" y="1167723"/>
              <a:ext cx="669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HNRNPAB</a:t>
              </a:r>
              <a:endParaRPr lang="en-US" sz="800" dirty="0"/>
            </a:p>
          </p:txBody>
        </p:sp>
        <p:grpSp>
          <p:nvGrpSpPr>
            <p:cNvPr id="61" name="Group 60"/>
            <p:cNvGrpSpPr/>
            <p:nvPr/>
          </p:nvGrpSpPr>
          <p:grpSpPr>
            <a:xfrm>
              <a:off x="6093305" y="1299129"/>
              <a:ext cx="629964" cy="682071"/>
              <a:chOff x="813925" y="156129"/>
              <a:chExt cx="629964" cy="682071"/>
            </a:xfrm>
          </p:grpSpPr>
          <p:sp>
            <p:nvSpPr>
              <p:cNvPr id="62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63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64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</p:grpSp>
      <p:grpSp>
        <p:nvGrpSpPr>
          <p:cNvPr id="18" name="Group 17"/>
          <p:cNvGrpSpPr/>
          <p:nvPr/>
        </p:nvGrpSpPr>
        <p:grpSpPr>
          <a:xfrm>
            <a:off x="3848992" y="1643014"/>
            <a:ext cx="1680549" cy="1192332"/>
            <a:chOff x="7311051" y="1156156"/>
            <a:chExt cx="1680549" cy="1206044"/>
          </a:xfrm>
        </p:grpSpPr>
        <p:pic>
          <p:nvPicPr>
            <p:cNvPr id="1035" name="Picture 11" descr="H:\gene\New folder\KCTD7.jpe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11051" y="1287463"/>
              <a:ext cx="1680549" cy="10747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6" name="TextBox 65"/>
            <p:cNvSpPr txBox="1"/>
            <p:nvPr/>
          </p:nvSpPr>
          <p:spPr>
            <a:xfrm>
              <a:off x="7324064" y="1156156"/>
              <a:ext cx="669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KCTD7</a:t>
              </a:r>
              <a:endParaRPr lang="en-US" sz="800" dirty="0"/>
            </a:p>
          </p:txBody>
        </p:sp>
        <p:grpSp>
          <p:nvGrpSpPr>
            <p:cNvPr id="67" name="Group 66"/>
            <p:cNvGrpSpPr/>
            <p:nvPr/>
          </p:nvGrpSpPr>
          <p:grpSpPr>
            <a:xfrm>
              <a:off x="7904436" y="1328301"/>
              <a:ext cx="629964" cy="682071"/>
              <a:chOff x="813925" y="156129"/>
              <a:chExt cx="629964" cy="682071"/>
            </a:xfrm>
          </p:grpSpPr>
          <p:sp>
            <p:nvSpPr>
              <p:cNvPr id="68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69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70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</p:grpSp>
      <p:sp>
        <p:nvSpPr>
          <p:cNvPr id="76" name="TextBox 57"/>
          <p:cNvSpPr txBox="1">
            <a:spLocks noChangeArrowheads="1"/>
          </p:cNvSpPr>
          <p:nvPr/>
        </p:nvSpPr>
        <p:spPr bwMode="auto">
          <a:xfrm rot="16200000">
            <a:off x="-107343" y="2025744"/>
            <a:ext cx="5139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US" altLang="en-US" sz="800" dirty="0"/>
              <a:t>reads</a:t>
            </a:r>
          </a:p>
        </p:txBody>
      </p:sp>
      <p:grpSp>
        <p:nvGrpSpPr>
          <p:cNvPr id="17" name="Group 16"/>
          <p:cNvGrpSpPr/>
          <p:nvPr/>
        </p:nvGrpSpPr>
        <p:grpSpPr>
          <a:xfrm>
            <a:off x="5557083" y="1651198"/>
            <a:ext cx="1614973" cy="1206222"/>
            <a:chOff x="152399" y="2316446"/>
            <a:chExt cx="1614973" cy="1206222"/>
          </a:xfrm>
        </p:grpSpPr>
        <p:pic>
          <p:nvPicPr>
            <p:cNvPr id="1036" name="Picture 12" descr="H:\gene\New folder\KIF1B.jpeg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2399" y="2427261"/>
              <a:ext cx="1614973" cy="10954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2" name="Group 71"/>
            <p:cNvGrpSpPr/>
            <p:nvPr/>
          </p:nvGrpSpPr>
          <p:grpSpPr>
            <a:xfrm>
              <a:off x="817836" y="2514600"/>
              <a:ext cx="629964" cy="682071"/>
              <a:chOff x="813925" y="156129"/>
              <a:chExt cx="629964" cy="682071"/>
            </a:xfrm>
          </p:grpSpPr>
          <p:sp>
            <p:nvSpPr>
              <p:cNvPr id="73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74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75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  <p:sp>
          <p:nvSpPr>
            <p:cNvPr id="77" name="TextBox 76"/>
            <p:cNvSpPr txBox="1"/>
            <p:nvPr/>
          </p:nvSpPr>
          <p:spPr>
            <a:xfrm>
              <a:off x="192880" y="2316446"/>
              <a:ext cx="5772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KIF1B</a:t>
              </a:r>
              <a:endParaRPr lang="en-US" sz="800" dirty="0"/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7330172" y="1663715"/>
            <a:ext cx="1694069" cy="1145106"/>
            <a:chOff x="3639931" y="2350734"/>
            <a:chExt cx="1694069" cy="1145106"/>
          </a:xfrm>
        </p:grpSpPr>
        <p:pic>
          <p:nvPicPr>
            <p:cNvPr id="1038" name="Picture 14" descr="H:\gene\New folder\RBM27.jpeg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9931" y="2438399"/>
              <a:ext cx="1694069" cy="105744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5" name="Group 84"/>
            <p:cNvGrpSpPr/>
            <p:nvPr/>
          </p:nvGrpSpPr>
          <p:grpSpPr>
            <a:xfrm>
              <a:off x="4267200" y="2479449"/>
              <a:ext cx="629964" cy="682071"/>
              <a:chOff x="813925" y="156129"/>
              <a:chExt cx="629964" cy="682071"/>
            </a:xfrm>
          </p:grpSpPr>
          <p:sp>
            <p:nvSpPr>
              <p:cNvPr id="86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87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88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  <p:sp>
          <p:nvSpPr>
            <p:cNvPr id="89" name="TextBox 88"/>
            <p:cNvSpPr txBox="1"/>
            <p:nvPr/>
          </p:nvSpPr>
          <p:spPr>
            <a:xfrm>
              <a:off x="3657600" y="2350734"/>
              <a:ext cx="5772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RBM27</a:t>
              </a:r>
              <a:endParaRPr lang="en-US" sz="800" dirty="0"/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217369" y="2782936"/>
            <a:ext cx="1726397" cy="1143000"/>
            <a:chOff x="5436403" y="2362200"/>
            <a:chExt cx="1726397" cy="1143000"/>
          </a:xfrm>
        </p:grpSpPr>
        <p:pic>
          <p:nvPicPr>
            <p:cNvPr id="1039" name="Picture 15" descr="H:\gene\New folder\RRBP1.jpeg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403" y="2427580"/>
              <a:ext cx="1726397" cy="10776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91" name="Group 90"/>
            <p:cNvGrpSpPr/>
            <p:nvPr/>
          </p:nvGrpSpPr>
          <p:grpSpPr>
            <a:xfrm>
              <a:off x="6092959" y="2481218"/>
              <a:ext cx="629964" cy="682071"/>
              <a:chOff x="813925" y="156129"/>
              <a:chExt cx="629964" cy="682071"/>
            </a:xfrm>
          </p:grpSpPr>
          <p:sp>
            <p:nvSpPr>
              <p:cNvPr id="92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93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94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  <p:sp>
          <p:nvSpPr>
            <p:cNvPr id="95" name="TextBox 94"/>
            <p:cNvSpPr txBox="1"/>
            <p:nvPr/>
          </p:nvSpPr>
          <p:spPr>
            <a:xfrm>
              <a:off x="5441021" y="2362200"/>
              <a:ext cx="5772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RRBP1</a:t>
              </a:r>
              <a:endParaRPr lang="en-US" sz="800" dirty="0"/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2042916" y="2786788"/>
            <a:ext cx="1731238" cy="1139471"/>
            <a:chOff x="7260362" y="2373666"/>
            <a:chExt cx="1731238" cy="1139471"/>
          </a:xfrm>
        </p:grpSpPr>
        <p:pic>
          <p:nvPicPr>
            <p:cNvPr id="1040" name="Picture 16" descr="H:\gene\New folder\SAP30L.jpeg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69821" y="2438400"/>
              <a:ext cx="1721779" cy="10747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97" name="Group 96"/>
            <p:cNvGrpSpPr/>
            <p:nvPr/>
          </p:nvGrpSpPr>
          <p:grpSpPr>
            <a:xfrm>
              <a:off x="7912300" y="2492684"/>
              <a:ext cx="629964" cy="682071"/>
              <a:chOff x="813925" y="156129"/>
              <a:chExt cx="629964" cy="682071"/>
            </a:xfrm>
          </p:grpSpPr>
          <p:sp>
            <p:nvSpPr>
              <p:cNvPr id="98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99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100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  <p:sp>
          <p:nvSpPr>
            <p:cNvPr id="101" name="TextBox 100"/>
            <p:cNvSpPr txBox="1"/>
            <p:nvPr/>
          </p:nvSpPr>
          <p:spPr>
            <a:xfrm>
              <a:off x="7260362" y="2373666"/>
              <a:ext cx="5772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SAP30L</a:t>
              </a:r>
              <a:endParaRPr lang="en-US" sz="800" dirty="0"/>
            </a:p>
          </p:txBody>
        </p:sp>
      </p:grpSp>
      <p:sp>
        <p:nvSpPr>
          <p:cNvPr id="107" name="TextBox 57"/>
          <p:cNvSpPr txBox="1">
            <a:spLocks noChangeArrowheads="1"/>
          </p:cNvSpPr>
          <p:nvPr/>
        </p:nvSpPr>
        <p:spPr bwMode="auto">
          <a:xfrm rot="16200000">
            <a:off x="-107343" y="3108428"/>
            <a:ext cx="5139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US" altLang="en-US" sz="800" dirty="0"/>
              <a:t>reads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3848992" y="2885707"/>
            <a:ext cx="1614972" cy="1040552"/>
            <a:chOff x="152400" y="3521084"/>
            <a:chExt cx="1614972" cy="1040552"/>
          </a:xfrm>
        </p:grpSpPr>
        <p:pic>
          <p:nvPicPr>
            <p:cNvPr id="1041" name="Picture 17" descr="H:\gene\New folder\STIL.jpeg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2400" y="3553568"/>
              <a:ext cx="1614972" cy="10080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03" name="Group 102"/>
            <p:cNvGrpSpPr/>
            <p:nvPr/>
          </p:nvGrpSpPr>
          <p:grpSpPr>
            <a:xfrm>
              <a:off x="817836" y="3597284"/>
              <a:ext cx="629964" cy="682071"/>
              <a:chOff x="813925" y="156129"/>
              <a:chExt cx="629964" cy="682071"/>
            </a:xfrm>
          </p:grpSpPr>
          <p:sp>
            <p:nvSpPr>
              <p:cNvPr id="104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105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106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  <p:sp>
          <p:nvSpPr>
            <p:cNvPr id="108" name="TextBox 107"/>
            <p:cNvSpPr txBox="1"/>
            <p:nvPr/>
          </p:nvSpPr>
          <p:spPr>
            <a:xfrm>
              <a:off x="152400" y="3521084"/>
              <a:ext cx="5772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STIL</a:t>
              </a:r>
              <a:endParaRPr lang="en-US" sz="800" dirty="0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5548698" y="2855083"/>
            <a:ext cx="1696059" cy="1084269"/>
            <a:chOff x="1855003" y="3477368"/>
            <a:chExt cx="1696059" cy="1084269"/>
          </a:xfrm>
        </p:grpSpPr>
        <p:pic>
          <p:nvPicPr>
            <p:cNvPr id="1042" name="Picture 18" descr="H:\gene\New folder\TNRC6B.jpeg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55003" y="3553569"/>
              <a:ext cx="1696059" cy="10080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0" name="Group 109"/>
            <p:cNvGrpSpPr/>
            <p:nvPr/>
          </p:nvGrpSpPr>
          <p:grpSpPr>
            <a:xfrm>
              <a:off x="2514600" y="3553568"/>
              <a:ext cx="629964" cy="682071"/>
              <a:chOff x="813925" y="156129"/>
              <a:chExt cx="629964" cy="682071"/>
            </a:xfrm>
          </p:grpSpPr>
          <p:sp>
            <p:nvSpPr>
              <p:cNvPr id="111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112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113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  <p:sp>
          <p:nvSpPr>
            <p:cNvPr id="114" name="TextBox 113"/>
            <p:cNvSpPr txBox="1"/>
            <p:nvPr/>
          </p:nvSpPr>
          <p:spPr>
            <a:xfrm>
              <a:off x="1883649" y="3477368"/>
              <a:ext cx="5772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TNRC6B</a:t>
              </a:r>
              <a:endParaRPr lang="en-US" sz="800" dirty="0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7303969" y="2799625"/>
            <a:ext cx="1752600" cy="1153821"/>
            <a:chOff x="5410200" y="3446468"/>
            <a:chExt cx="1752600" cy="1153821"/>
          </a:xfrm>
        </p:grpSpPr>
        <p:grpSp>
          <p:nvGrpSpPr>
            <p:cNvPr id="2" name="Group 1"/>
            <p:cNvGrpSpPr/>
            <p:nvPr/>
          </p:nvGrpSpPr>
          <p:grpSpPr>
            <a:xfrm>
              <a:off x="5410200" y="3446468"/>
              <a:ext cx="1752600" cy="1153821"/>
              <a:chOff x="5410200" y="3446468"/>
              <a:chExt cx="1752600" cy="1153821"/>
            </a:xfrm>
          </p:grpSpPr>
          <p:pic>
            <p:nvPicPr>
              <p:cNvPr id="1044" name="Picture 20" descr="H:\gene\New folder\ZNF92.jpeg"/>
              <p:cNvPicPr>
                <a:picLocks noChangeAspect="1" noChangeArrowheads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36403" y="3522669"/>
                <a:ext cx="1726397" cy="107762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26" name="TextBox 125"/>
              <p:cNvSpPr txBox="1"/>
              <p:nvPr/>
            </p:nvSpPr>
            <p:spPr>
              <a:xfrm>
                <a:off x="5410200" y="3446468"/>
                <a:ext cx="57721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 ZNF92</a:t>
                </a:r>
                <a:endParaRPr lang="en-US" sz="800" dirty="0"/>
              </a:p>
            </p:txBody>
          </p:sp>
        </p:grpSp>
        <p:grpSp>
          <p:nvGrpSpPr>
            <p:cNvPr id="122" name="Group 121"/>
            <p:cNvGrpSpPr/>
            <p:nvPr/>
          </p:nvGrpSpPr>
          <p:grpSpPr>
            <a:xfrm>
              <a:off x="6096716" y="3550752"/>
              <a:ext cx="629964" cy="682071"/>
              <a:chOff x="813925" y="156129"/>
              <a:chExt cx="629964" cy="682071"/>
            </a:xfrm>
          </p:grpSpPr>
          <p:sp>
            <p:nvSpPr>
              <p:cNvPr id="123" name="TextBox 54"/>
              <p:cNvSpPr txBox="1">
                <a:spLocks noChangeArrowheads="1"/>
              </p:cNvSpPr>
              <p:nvPr/>
            </p:nvSpPr>
            <p:spPr bwMode="auto">
              <a:xfrm>
                <a:off x="821789" y="156129"/>
                <a:ext cx="55488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>
                    <a:solidFill>
                      <a:srgbClr val="FF0000"/>
                    </a:solidFill>
                  </a:rPr>
                  <a:t>SOX9</a:t>
                </a:r>
              </a:p>
            </p:txBody>
          </p:sp>
          <p:sp>
            <p:nvSpPr>
              <p:cNvPr id="124" name="TextBox 55"/>
              <p:cNvSpPr txBox="1">
                <a:spLocks noChangeArrowheads="1"/>
              </p:cNvSpPr>
              <p:nvPr/>
            </p:nvSpPr>
            <p:spPr bwMode="auto">
              <a:xfrm>
                <a:off x="813925" y="391212"/>
                <a:ext cx="6299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>
                    <a:solidFill>
                      <a:srgbClr val="0070C0"/>
                    </a:solidFill>
                  </a:rPr>
                  <a:t>NF-YA</a:t>
                </a:r>
              </a:p>
            </p:txBody>
          </p:sp>
          <p:sp>
            <p:nvSpPr>
              <p:cNvPr id="125" name="TextBox 56"/>
              <p:cNvSpPr txBox="1">
                <a:spLocks noChangeArrowheads="1"/>
              </p:cNvSpPr>
              <p:nvPr/>
            </p:nvSpPr>
            <p:spPr bwMode="auto">
              <a:xfrm>
                <a:off x="820233" y="622756"/>
                <a:ext cx="5480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800" dirty="0"/>
                  <a:t>input</a:t>
                </a:r>
              </a:p>
            </p:txBody>
          </p:sp>
        </p:grpSp>
      </p:grpSp>
      <p:sp>
        <p:nvSpPr>
          <p:cNvPr id="145" name="TextBox 144"/>
          <p:cNvSpPr txBox="1"/>
          <p:nvPr/>
        </p:nvSpPr>
        <p:spPr>
          <a:xfrm>
            <a:off x="6363405" y="6316624"/>
            <a:ext cx="2623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4</a:t>
            </a:r>
            <a:endParaRPr lang="en-US" dirty="0"/>
          </a:p>
        </p:txBody>
      </p:sp>
      <p:sp>
        <p:nvSpPr>
          <p:cNvPr id="115" name="TextBox 114"/>
          <p:cNvSpPr txBox="1"/>
          <p:nvPr/>
        </p:nvSpPr>
        <p:spPr>
          <a:xfrm>
            <a:off x="101684" y="159997"/>
            <a:ext cx="311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16" name="TextBox 115"/>
          <p:cNvSpPr txBox="1"/>
          <p:nvPr/>
        </p:nvSpPr>
        <p:spPr>
          <a:xfrm>
            <a:off x="101684" y="3953446"/>
            <a:ext cx="311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7077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327</TotalTime>
  <Words>72</Words>
  <Application>Microsoft Office PowerPoint</Application>
  <PresentationFormat>On-screen Show (4:3)</PresentationFormat>
  <Paragraphs>6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enpathwa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ME runs</dc:title>
  <dc:creator>Paul Labhart</dc:creator>
  <cp:lastModifiedBy>moriakiy</cp:lastModifiedBy>
  <cp:revision>1601</cp:revision>
  <cp:lastPrinted>2014-02-08T00:35:07Z</cp:lastPrinted>
  <dcterms:created xsi:type="dcterms:W3CDTF">2013-01-30T00:52:15Z</dcterms:created>
  <dcterms:modified xsi:type="dcterms:W3CDTF">2015-05-12T15:29:07Z</dcterms:modified>
</cp:coreProperties>
</file>